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4" r:id="rId7"/>
    <p:sldId id="262" r:id="rId8"/>
    <p:sldId id="263" r:id="rId9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EC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76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8266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998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125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0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701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145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357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744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319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575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594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CE1B1-BE09-43D8-AFD2-A273E8676430}" type="datetimeFigureOut">
              <a:rPr lang="en-US" smtClean="0"/>
              <a:t>1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69700-C6A6-4CD2-A57B-8B4C84CC7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5654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949999"/>
            <a:ext cx="6065770" cy="806160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764189" y="1663600"/>
            <a:ext cx="708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CTL+veh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5790221" y="3644800"/>
            <a:ext cx="656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veh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5638800" y="5397400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Ac-SDKP</a:t>
            </a:r>
            <a:endParaRPr lang="en-US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1160073" y="302535"/>
            <a:ext cx="44787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Supporting information</a:t>
            </a:r>
          </a:p>
          <a:p>
            <a:pPr algn="ctr"/>
            <a:r>
              <a:rPr lang="en-US" dirty="0" smtClean="0"/>
              <a:t>Figure 3C and 3D original flow cytometry data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190500" y="117869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1 Fig.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1562801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227" b="3020"/>
          <a:stretch/>
        </p:blipFill>
        <p:spPr>
          <a:xfrm>
            <a:off x="28575" y="487201"/>
            <a:ext cx="5643626" cy="85806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925988" y="970002"/>
            <a:ext cx="17238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TL+veh</a:t>
            </a:r>
            <a:endParaRPr lang="en-US" sz="1200" dirty="0" smtClean="0"/>
          </a:p>
          <a:p>
            <a:r>
              <a:rPr lang="en-US" sz="1200" dirty="0" smtClean="0"/>
              <a:t>(data was discarded because sample was lost during staining)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4925988" y="2667000"/>
            <a:ext cx="656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veh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4800600" y="6248400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Ac-SDKP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4828196" y="4433499"/>
            <a:ext cx="1010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CTL+Ac-SDKP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190500" y="117869"/>
            <a:ext cx="2263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1 Fig. (continuation)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3282463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87201"/>
            <a:ext cx="6502514" cy="86420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514248" y="1099750"/>
            <a:ext cx="708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CTL+veh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5540280" y="4648200"/>
            <a:ext cx="656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veh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5388860" y="6378148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Ac-SDKP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5362828" y="2819400"/>
            <a:ext cx="1010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CTL+Ac-SDKP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190500" y="117869"/>
            <a:ext cx="2263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1 Fig. (continuation)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3488260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655001" y="1752600"/>
            <a:ext cx="708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CTL+veh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5544385" y="5943600"/>
            <a:ext cx="1010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CTL+Ac-SDKP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5572960" y="3846045"/>
            <a:ext cx="656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veh</a:t>
            </a:r>
            <a:endParaRPr lang="en-US" sz="1200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62000"/>
            <a:ext cx="5655001" cy="7515678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90500" y="117869"/>
            <a:ext cx="2263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1 Fig. (continuation)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0828454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54" y="457199"/>
            <a:ext cx="5561491" cy="739140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330570" y="3657600"/>
            <a:ext cx="656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veh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5330570" y="1524000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Ac-SDKP</a:t>
            </a:r>
            <a:endParaRPr lang="en-US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190500" y="117869"/>
            <a:ext cx="2263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1 Fig. (continuation)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7273530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609600"/>
            <a:ext cx="6298984" cy="837155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568301" y="5819001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Ac-SDKP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5604669" y="1600200"/>
            <a:ext cx="656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veh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5536905" y="3530173"/>
            <a:ext cx="1010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CTL+Ac-SDKP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190500" y="117869"/>
            <a:ext cx="2263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1 Fig. (continuation)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6693842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3"/>
          <a:stretch/>
        </p:blipFill>
        <p:spPr>
          <a:xfrm>
            <a:off x="28575" y="381000"/>
            <a:ext cx="6111742" cy="8615775"/>
          </a:xfrm>
        </p:spPr>
      </p:pic>
      <p:sp>
        <p:nvSpPr>
          <p:cNvPr id="5" name="TextBox 4"/>
          <p:cNvSpPr txBox="1"/>
          <p:nvPr/>
        </p:nvSpPr>
        <p:spPr>
          <a:xfrm>
            <a:off x="5388862" y="1099750"/>
            <a:ext cx="708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CTL+veh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5414894" y="4648200"/>
            <a:ext cx="656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veh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5263474" y="6378148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I+Ac-SDKP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5237442" y="2819400"/>
            <a:ext cx="1010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CTL+Ac-SDKP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190500" y="117869"/>
            <a:ext cx="2263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1 Fig. (continuation)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2073368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457200"/>
            <a:ext cx="6324600" cy="840559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90500" y="117869"/>
            <a:ext cx="2263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1 Fig. (continuation)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908710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</TotalTime>
  <Words>89</Words>
  <Application>Microsoft Office PowerPoint</Application>
  <PresentationFormat>On-screen Show (4:3)</PresentationFormat>
  <Paragraphs>34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Iow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kagawa, Pablo</dc:creator>
  <cp:lastModifiedBy>Nakagawa, Pablo</cp:lastModifiedBy>
  <cp:revision>9</cp:revision>
  <dcterms:created xsi:type="dcterms:W3CDTF">2017-11-13T16:37:39Z</dcterms:created>
  <dcterms:modified xsi:type="dcterms:W3CDTF">2018-01-11T22:55:23Z</dcterms:modified>
</cp:coreProperties>
</file>